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64" d="100"/>
          <a:sy n="64" d="100"/>
        </p:scale>
        <p:origin x="1482" y="6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B9AD435-15F0-4DDC-9F9F-7DBB3B59CB59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5D8EC0-FBD7-44C1-89D0-9487B7152E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57924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75D8EC0-FBD7-44C1-89D0-9487B7152E3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5099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E936A-174E-493C-8CBC-9F09A8929FD9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F7683-ECDA-43D3-AD16-74A9BFD982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5967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E936A-174E-493C-8CBC-9F09A8929FD9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F7683-ECDA-43D3-AD16-74A9BFD982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3185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E936A-174E-493C-8CBC-9F09A8929FD9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F7683-ECDA-43D3-AD16-74A9BFD982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5964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E936A-174E-493C-8CBC-9F09A8929FD9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F7683-ECDA-43D3-AD16-74A9BFD982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493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E936A-174E-493C-8CBC-9F09A8929FD9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F7683-ECDA-43D3-AD16-74A9BFD982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860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E936A-174E-493C-8CBC-9F09A8929FD9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F7683-ECDA-43D3-AD16-74A9BFD982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61189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E936A-174E-493C-8CBC-9F09A8929FD9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F7683-ECDA-43D3-AD16-74A9BFD982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568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E936A-174E-493C-8CBC-9F09A8929FD9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F7683-ECDA-43D3-AD16-74A9BFD982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05734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E936A-174E-493C-8CBC-9F09A8929FD9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F7683-ECDA-43D3-AD16-74A9BFD982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38152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E936A-174E-493C-8CBC-9F09A8929FD9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F7683-ECDA-43D3-AD16-74A9BFD982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222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E936A-174E-493C-8CBC-9F09A8929FD9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F7683-ECDA-43D3-AD16-74A9BFD982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41398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3E936A-174E-493C-8CBC-9F09A8929FD9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BF7683-ECDA-43D3-AD16-74A9BFD982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4970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2803" y="1676400"/>
            <a:ext cx="7302869" cy="4962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952803" y="533400"/>
            <a:ext cx="803879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ure </a:t>
            </a:r>
            <a:r>
              <a:rPr lang="en-US" b="1" dirty="0" smtClean="0"/>
              <a:t>S1. </a:t>
            </a:r>
            <a:r>
              <a:rPr lang="en-US" dirty="0" smtClean="0"/>
              <a:t>DAS-ELISA values of 10 selected transgenic events and non-transgenic cv Desiree, graft inoculated with PLRV 30, 60 and 90 days post graft inoculation. Healthy: Desiree mock inoculated by grafting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890213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38</Words>
  <Application>Microsoft Office PowerPoint</Application>
  <PresentationFormat>On-screen Show (4:3)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euze, Jan (CIP)</dc:creator>
  <cp:lastModifiedBy>Kreuze, Jan (CIP)</cp:lastModifiedBy>
  <cp:revision>3</cp:revision>
  <dcterms:created xsi:type="dcterms:W3CDTF">2016-01-11T19:33:53Z</dcterms:created>
  <dcterms:modified xsi:type="dcterms:W3CDTF">2016-07-26T08:16:21Z</dcterms:modified>
</cp:coreProperties>
</file>